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670" r:id="rId2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F8D4B"/>
    <a:srgbClr val="E739D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968202A-90FD-4BA8-BBE0-BACF6D498E67}" v="30" dt="2025-01-13T07:00:30.31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B301B821-A1FF-4177-AEE7-76D212191A09}" styleName="中間スタイル 1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3B4B98B0-60AC-42C2-AFA5-B58CD77FA1E5}" styleName="淡色スタイル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3447" autoAdjust="0"/>
  </p:normalViewPr>
  <p:slideViewPr>
    <p:cSldViewPr snapToGrid="0">
      <p:cViewPr varScale="1">
        <p:scale>
          <a:sx n="60" d="100"/>
          <a:sy n="60" d="100"/>
        </p:scale>
        <p:origin x="64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handoutMaster" Target="handoutMasters/handout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友美 山﨑" userId="7b25e37ca7f83a67" providerId="LiveId" clId="{BA069443-6CD1-421E-862C-C36EE87A92FD}"/>
    <pc:docChg chg="custSel modSld">
      <pc:chgData name="友美 山﨑" userId="7b25e37ca7f83a67" providerId="LiveId" clId="{BA069443-6CD1-421E-862C-C36EE87A92FD}" dt="2024-12-31T05:56:31.712" v="412" actId="20577"/>
      <pc:docMkLst>
        <pc:docMk/>
      </pc:docMkLst>
      <pc:sldChg chg="modSp mod">
        <pc:chgData name="友美 山﨑" userId="7b25e37ca7f83a67" providerId="LiveId" clId="{BA069443-6CD1-421E-862C-C36EE87A92FD}" dt="2024-12-31T05:44:16.735" v="5" actId="20577"/>
        <pc:sldMkLst>
          <pc:docMk/>
          <pc:sldMk cId="1781468713" sldId="3688"/>
        </pc:sldMkLst>
        <pc:spChg chg="mod">
          <ac:chgData name="友美 山﨑" userId="7b25e37ca7f83a67" providerId="LiveId" clId="{BA069443-6CD1-421E-862C-C36EE87A92FD}" dt="2024-12-31T05:44:16.735" v="5" actId="20577"/>
          <ac:spMkLst>
            <pc:docMk/>
            <pc:sldMk cId="1781468713" sldId="3688"/>
            <ac:spMk id="2" creationId="{2D9599E9-1A7D-FFED-4AEA-B0E456E88C77}"/>
          </ac:spMkLst>
        </pc:spChg>
      </pc:sldChg>
      <pc:sldChg chg="modSp mod">
        <pc:chgData name="友美 山﨑" userId="7b25e37ca7f83a67" providerId="LiveId" clId="{BA069443-6CD1-421E-862C-C36EE87A92FD}" dt="2024-12-31T05:56:31.712" v="412" actId="20577"/>
        <pc:sldMkLst>
          <pc:docMk/>
          <pc:sldMk cId="8810058" sldId="3785"/>
        </pc:sldMkLst>
        <pc:spChg chg="mod">
          <ac:chgData name="友美 山﨑" userId="7b25e37ca7f83a67" providerId="LiveId" clId="{BA069443-6CD1-421E-862C-C36EE87A92FD}" dt="2024-12-31T05:44:59.275" v="51" actId="13926"/>
          <ac:spMkLst>
            <pc:docMk/>
            <pc:sldMk cId="8810058" sldId="3785"/>
            <ac:spMk id="2" creationId="{07D361DE-41CD-88A6-2B79-C7172E46518C}"/>
          </ac:spMkLst>
        </pc:spChg>
        <pc:spChg chg="mod">
          <ac:chgData name="友美 山﨑" userId="7b25e37ca7f83a67" providerId="LiveId" clId="{BA069443-6CD1-421E-862C-C36EE87A92FD}" dt="2024-12-31T05:47:01.457" v="138" actId="1035"/>
          <ac:spMkLst>
            <pc:docMk/>
            <pc:sldMk cId="8810058" sldId="3785"/>
            <ac:spMk id="4" creationId="{8F319CFC-B2FD-B295-D8F0-C0301C320BA3}"/>
          </ac:spMkLst>
        </pc:spChg>
        <pc:graphicFrameChg chg="mod modGraphic">
          <ac:chgData name="友美 山﨑" userId="7b25e37ca7f83a67" providerId="LiveId" clId="{BA069443-6CD1-421E-862C-C36EE87A92FD}" dt="2024-12-31T05:56:31.712" v="412" actId="20577"/>
          <ac:graphicFrameMkLst>
            <pc:docMk/>
            <pc:sldMk cId="8810058" sldId="3785"/>
            <ac:graphicFrameMk id="3" creationId="{FBCB0899-E682-C8CD-340F-FA4AA5B262BF}"/>
          </ac:graphicFrameMkLst>
        </pc:graphicFrameChg>
      </pc:sldChg>
    </pc:docChg>
  </pc:docChgLst>
  <pc:docChgLst>
    <pc:chgData name="友美 山﨑" userId="7b25e37ca7f83a67" providerId="LiveId" clId="{D968202A-90FD-4BA8-BBE0-BACF6D498E67}"/>
    <pc:docChg chg="undo custSel modSld">
      <pc:chgData name="友美 山﨑" userId="7b25e37ca7f83a67" providerId="LiveId" clId="{D968202A-90FD-4BA8-BBE0-BACF6D498E67}" dt="2025-01-13T07:00:43.556" v="2753" actId="20577"/>
      <pc:docMkLst>
        <pc:docMk/>
      </pc:docMkLst>
      <pc:sldChg chg="modSp mod">
        <pc:chgData name="友美 山﨑" userId="7b25e37ca7f83a67" providerId="LiveId" clId="{D968202A-90FD-4BA8-BBE0-BACF6D498E67}" dt="2025-01-13T04:37:13.501" v="129" actId="20577"/>
        <pc:sldMkLst>
          <pc:docMk/>
          <pc:sldMk cId="3960362887" sldId="316"/>
        </pc:sldMkLst>
        <pc:spChg chg="mod">
          <ac:chgData name="友美 山﨑" userId="7b25e37ca7f83a67" providerId="LiveId" clId="{D968202A-90FD-4BA8-BBE0-BACF6D498E67}" dt="2025-01-13T04:37:13.501" v="129" actId="20577"/>
          <ac:spMkLst>
            <pc:docMk/>
            <pc:sldMk cId="3960362887" sldId="316"/>
            <ac:spMk id="3" creationId="{6D2AAA17-D506-D81E-C0BD-C2F033E70DDD}"/>
          </ac:spMkLst>
        </pc:spChg>
      </pc:sldChg>
      <pc:sldChg chg="addSp delSp modSp mod">
        <pc:chgData name="友美 山﨑" userId="7b25e37ca7f83a67" providerId="LiveId" clId="{D968202A-90FD-4BA8-BBE0-BACF6D498E67}" dt="2025-01-13T05:52:21.376" v="2723" actId="20577"/>
        <pc:sldMkLst>
          <pc:docMk/>
          <pc:sldMk cId="1781468713" sldId="3688"/>
        </pc:sldMkLst>
        <pc:spChg chg="mod">
          <ac:chgData name="友美 山﨑" userId="7b25e37ca7f83a67" providerId="LiveId" clId="{D968202A-90FD-4BA8-BBE0-BACF6D498E67}" dt="2025-01-13T05:52:21.376" v="2723" actId="20577"/>
          <ac:spMkLst>
            <pc:docMk/>
            <pc:sldMk cId="1781468713" sldId="3688"/>
            <ac:spMk id="2" creationId="{2D9599E9-1A7D-FFED-4AEA-B0E456E88C77}"/>
          </ac:spMkLst>
        </pc:spChg>
        <pc:spChg chg="mod">
          <ac:chgData name="友美 山﨑" userId="7b25e37ca7f83a67" providerId="LiveId" clId="{D968202A-90FD-4BA8-BBE0-BACF6D498E67}" dt="2025-01-13T05:43:03.394" v="1544" actId="1038"/>
          <ac:spMkLst>
            <pc:docMk/>
            <pc:sldMk cId="1781468713" sldId="3688"/>
            <ac:spMk id="3" creationId="{2FB90152-AAF5-6F0C-9B74-AFE2E4394A98}"/>
          </ac:spMkLst>
        </pc:spChg>
        <pc:spChg chg="mod">
          <ac:chgData name="友美 山﨑" userId="7b25e37ca7f83a67" providerId="LiveId" clId="{D968202A-90FD-4BA8-BBE0-BACF6D498E67}" dt="2025-01-13T05:43:03.394" v="1544" actId="1038"/>
          <ac:spMkLst>
            <pc:docMk/>
            <pc:sldMk cId="1781468713" sldId="3688"/>
            <ac:spMk id="11" creationId="{0BB86E48-4567-6A2A-9297-2CC3C7724149}"/>
          </ac:spMkLst>
        </pc:spChg>
        <pc:spChg chg="mod">
          <ac:chgData name="友美 山﨑" userId="7b25e37ca7f83a67" providerId="LiveId" clId="{D968202A-90FD-4BA8-BBE0-BACF6D498E67}" dt="2025-01-13T05:43:03.394" v="1544" actId="1038"/>
          <ac:spMkLst>
            <pc:docMk/>
            <pc:sldMk cId="1781468713" sldId="3688"/>
            <ac:spMk id="12" creationId="{9E2FEE02-B55C-D23E-C645-B597D000AB98}"/>
          </ac:spMkLst>
        </pc:spChg>
        <pc:spChg chg="mod">
          <ac:chgData name="友美 山﨑" userId="7b25e37ca7f83a67" providerId="LiveId" clId="{D968202A-90FD-4BA8-BBE0-BACF6D498E67}" dt="2025-01-13T05:43:03.394" v="1544" actId="1038"/>
          <ac:spMkLst>
            <pc:docMk/>
            <pc:sldMk cId="1781468713" sldId="3688"/>
            <ac:spMk id="14" creationId="{9074A768-DEB8-9BCD-B381-13F2E498D159}"/>
          </ac:spMkLst>
        </pc:spChg>
        <pc:spChg chg="mod">
          <ac:chgData name="友美 山﨑" userId="7b25e37ca7f83a67" providerId="LiveId" clId="{D968202A-90FD-4BA8-BBE0-BACF6D498E67}" dt="2025-01-13T05:43:03.394" v="1544" actId="1038"/>
          <ac:spMkLst>
            <pc:docMk/>
            <pc:sldMk cId="1781468713" sldId="3688"/>
            <ac:spMk id="15" creationId="{2F45B593-ECB1-34DE-8DD3-9FA9E23A22CB}"/>
          </ac:spMkLst>
        </pc:spChg>
        <pc:spChg chg="mod">
          <ac:chgData name="友美 山﨑" userId="7b25e37ca7f83a67" providerId="LiveId" clId="{D968202A-90FD-4BA8-BBE0-BACF6D498E67}" dt="2025-01-13T05:40:43.321" v="1170" actId="1036"/>
          <ac:spMkLst>
            <pc:docMk/>
            <pc:sldMk cId="1781468713" sldId="3688"/>
            <ac:spMk id="29" creationId="{F2EBEDF0-C5CD-BD0E-A922-5A76C665D6A6}"/>
          </ac:spMkLst>
        </pc:spChg>
        <pc:spChg chg="add del">
          <ac:chgData name="友美 山﨑" userId="7b25e37ca7f83a67" providerId="LiveId" clId="{D968202A-90FD-4BA8-BBE0-BACF6D498E67}" dt="2025-01-13T05:33:28.250" v="137" actId="478"/>
          <ac:spMkLst>
            <pc:docMk/>
            <pc:sldMk cId="1781468713" sldId="3688"/>
            <ac:spMk id="52" creationId="{90A25E9A-7BA7-5714-4002-A5779CB823E6}"/>
          </ac:spMkLst>
        </pc:spChg>
        <pc:spChg chg="mod">
          <ac:chgData name="友美 山﨑" userId="7b25e37ca7f83a67" providerId="LiveId" clId="{D968202A-90FD-4BA8-BBE0-BACF6D498E67}" dt="2025-01-13T05:35:49.271" v="571" actId="208"/>
          <ac:spMkLst>
            <pc:docMk/>
            <pc:sldMk cId="1781468713" sldId="3688"/>
            <ac:spMk id="53" creationId="{DBB23A8A-21AA-962C-DD90-78C87ADD0D11}"/>
          </ac:spMkLst>
        </pc:spChg>
        <pc:spChg chg="mod">
          <ac:chgData name="友美 山﨑" userId="7b25e37ca7f83a67" providerId="LiveId" clId="{D968202A-90FD-4BA8-BBE0-BACF6D498E67}" dt="2025-01-13T05:35:26.920" v="568" actId="207"/>
          <ac:spMkLst>
            <pc:docMk/>
            <pc:sldMk cId="1781468713" sldId="3688"/>
            <ac:spMk id="54" creationId="{2F317F1E-4A4D-D108-3621-B6AA3FCE39A6}"/>
          </ac:spMkLst>
        </pc:spChg>
        <pc:spChg chg="mod">
          <ac:chgData name="友美 山﨑" userId="7b25e37ca7f83a67" providerId="LiveId" clId="{D968202A-90FD-4BA8-BBE0-BACF6D498E67}" dt="2025-01-13T05:43:03.394" v="1544" actId="1038"/>
          <ac:spMkLst>
            <pc:docMk/>
            <pc:sldMk cId="1781468713" sldId="3688"/>
            <ac:spMk id="60" creationId="{D6E0BEC4-FF11-192A-DCDE-81FEED3141CF}"/>
          </ac:spMkLst>
        </pc:spChg>
        <pc:spChg chg="add del">
          <ac:chgData name="友美 山﨑" userId="7b25e37ca7f83a67" providerId="LiveId" clId="{D968202A-90FD-4BA8-BBE0-BACF6D498E67}" dt="2025-01-13T05:33:36.682" v="139" actId="478"/>
          <ac:spMkLst>
            <pc:docMk/>
            <pc:sldMk cId="1781468713" sldId="3688"/>
            <ac:spMk id="63" creationId="{CBCE5597-5276-188E-E620-62B3A5F3134F}"/>
          </ac:spMkLst>
        </pc:spChg>
        <pc:spChg chg="add mod">
          <ac:chgData name="友美 山﨑" userId="7b25e37ca7f83a67" providerId="LiveId" clId="{D968202A-90FD-4BA8-BBE0-BACF6D498E67}" dt="2025-01-13T05:36:22.643" v="689" actId="1037"/>
          <ac:spMkLst>
            <pc:docMk/>
            <pc:sldMk cId="1781468713" sldId="3688"/>
            <ac:spMk id="66" creationId="{433A4D3A-04E4-C270-5B3C-E58AD778DB4E}"/>
          </ac:spMkLst>
        </pc:spChg>
        <pc:spChg chg="add mod">
          <ac:chgData name="友美 山﨑" userId="7b25e37ca7f83a67" providerId="LiveId" clId="{D968202A-90FD-4BA8-BBE0-BACF6D498E67}" dt="2025-01-13T05:43:03.394" v="1544" actId="1038"/>
          <ac:spMkLst>
            <pc:docMk/>
            <pc:sldMk cId="1781468713" sldId="3688"/>
            <ac:spMk id="67" creationId="{27036A31-0661-85AA-3E85-005E7F32B5FD}"/>
          </ac:spMkLst>
        </pc:spChg>
        <pc:spChg chg="add mod">
          <ac:chgData name="友美 山﨑" userId="7b25e37ca7f83a67" providerId="LiveId" clId="{D968202A-90FD-4BA8-BBE0-BACF6D498E67}" dt="2025-01-13T05:39:18.002" v="885" actId="1037"/>
          <ac:spMkLst>
            <pc:docMk/>
            <pc:sldMk cId="1781468713" sldId="3688"/>
            <ac:spMk id="68" creationId="{ECF60E58-4990-044C-19F0-EA534E6256DA}"/>
          </ac:spMkLst>
        </pc:spChg>
        <pc:spChg chg="add mod">
          <ac:chgData name="友美 山﨑" userId="7b25e37ca7f83a67" providerId="LiveId" clId="{D968202A-90FD-4BA8-BBE0-BACF6D498E67}" dt="2025-01-13T05:39:35.764" v="975" actId="1036"/>
          <ac:spMkLst>
            <pc:docMk/>
            <pc:sldMk cId="1781468713" sldId="3688"/>
            <ac:spMk id="69" creationId="{27EF5228-5E6E-5B20-BB29-F74B5356D958}"/>
          </ac:spMkLst>
        </pc:spChg>
        <pc:spChg chg="add mod">
          <ac:chgData name="友美 山﨑" userId="7b25e37ca7f83a67" providerId="LiveId" clId="{D968202A-90FD-4BA8-BBE0-BACF6D498E67}" dt="2025-01-13T05:40:07.746" v="1085" actId="1038"/>
          <ac:spMkLst>
            <pc:docMk/>
            <pc:sldMk cId="1781468713" sldId="3688"/>
            <ac:spMk id="70" creationId="{C2DB78F7-F69F-DEB5-6569-277E5B26FC14}"/>
          </ac:spMkLst>
        </pc:spChg>
        <pc:spChg chg="add mod">
          <ac:chgData name="友美 山﨑" userId="7b25e37ca7f83a67" providerId="LiveId" clId="{D968202A-90FD-4BA8-BBE0-BACF6D498E67}" dt="2025-01-13T05:40:47.405" v="1174" actId="1035"/>
          <ac:spMkLst>
            <pc:docMk/>
            <pc:sldMk cId="1781468713" sldId="3688"/>
            <ac:spMk id="71" creationId="{8054F2BB-B688-C26E-C6C4-6885EE7D665A}"/>
          </ac:spMkLst>
        </pc:spChg>
        <pc:spChg chg="add mod">
          <ac:chgData name="友美 山﨑" userId="7b25e37ca7f83a67" providerId="LiveId" clId="{D968202A-90FD-4BA8-BBE0-BACF6D498E67}" dt="2025-01-13T05:43:03.394" v="1544" actId="1038"/>
          <ac:spMkLst>
            <pc:docMk/>
            <pc:sldMk cId="1781468713" sldId="3688"/>
            <ac:spMk id="72" creationId="{6F6214F2-9531-5CA8-8E70-CC5ABD21C3E2}"/>
          </ac:spMkLst>
        </pc:spChg>
        <pc:spChg chg="add del mod">
          <ac:chgData name="友美 山﨑" userId="7b25e37ca7f83a67" providerId="LiveId" clId="{D968202A-90FD-4BA8-BBE0-BACF6D498E67}" dt="2025-01-13T05:41:18.965" v="1271" actId="478"/>
          <ac:spMkLst>
            <pc:docMk/>
            <pc:sldMk cId="1781468713" sldId="3688"/>
            <ac:spMk id="73" creationId="{8BFB0A6D-1724-E927-80CE-BA6B42721A01}"/>
          </ac:spMkLst>
        </pc:spChg>
        <pc:spChg chg="add mod">
          <ac:chgData name="友美 山﨑" userId="7b25e37ca7f83a67" providerId="LiveId" clId="{D968202A-90FD-4BA8-BBE0-BACF6D498E67}" dt="2025-01-13T05:43:03.394" v="1544" actId="1038"/>
          <ac:spMkLst>
            <pc:docMk/>
            <pc:sldMk cId="1781468713" sldId="3688"/>
            <ac:spMk id="74" creationId="{073FD1E3-DB74-48FF-3F13-67A0BE838D60}"/>
          </ac:spMkLst>
        </pc:spChg>
        <pc:spChg chg="add del mod">
          <ac:chgData name="友美 山﨑" userId="7b25e37ca7f83a67" providerId="LiveId" clId="{D968202A-90FD-4BA8-BBE0-BACF6D498E67}" dt="2025-01-13T05:41:51.040" v="1401" actId="478"/>
          <ac:spMkLst>
            <pc:docMk/>
            <pc:sldMk cId="1781468713" sldId="3688"/>
            <ac:spMk id="75" creationId="{56362C3C-D380-F4B9-FF3C-A5588AB90A5E}"/>
          </ac:spMkLst>
        </pc:spChg>
        <pc:spChg chg="add mod">
          <ac:chgData name="友美 山﨑" userId="7b25e37ca7f83a67" providerId="LiveId" clId="{D968202A-90FD-4BA8-BBE0-BACF6D498E67}" dt="2025-01-13T05:43:03.394" v="1544" actId="1038"/>
          <ac:spMkLst>
            <pc:docMk/>
            <pc:sldMk cId="1781468713" sldId="3688"/>
            <ac:spMk id="76" creationId="{BB425C22-76D2-A15E-7BDE-779C81037250}"/>
          </ac:spMkLst>
        </pc:spChg>
        <pc:spChg chg="add del mod">
          <ac:chgData name="友美 山﨑" userId="7b25e37ca7f83a67" providerId="LiveId" clId="{D968202A-90FD-4BA8-BBE0-BACF6D498E67}" dt="2025-01-13T05:43:13.916" v="1557" actId="478"/>
          <ac:spMkLst>
            <pc:docMk/>
            <pc:sldMk cId="1781468713" sldId="3688"/>
            <ac:spMk id="77" creationId="{FEAAF9B7-5AC3-A6D5-F90D-845E14E6E946}"/>
          </ac:spMkLst>
        </pc:spChg>
        <pc:spChg chg="add mod">
          <ac:chgData name="友美 山﨑" userId="7b25e37ca7f83a67" providerId="LiveId" clId="{D968202A-90FD-4BA8-BBE0-BACF6D498E67}" dt="2025-01-13T05:43:25.702" v="1637" actId="1036"/>
          <ac:spMkLst>
            <pc:docMk/>
            <pc:sldMk cId="1781468713" sldId="3688"/>
            <ac:spMk id="78" creationId="{B130BE9B-AF85-2142-0DE4-0CF258DA04CB}"/>
          </ac:spMkLst>
        </pc:spChg>
        <pc:spChg chg="add mod">
          <ac:chgData name="友美 山﨑" userId="7b25e37ca7f83a67" providerId="LiveId" clId="{D968202A-90FD-4BA8-BBE0-BACF6D498E67}" dt="2025-01-13T05:43:56.138" v="1738" actId="1038"/>
          <ac:spMkLst>
            <pc:docMk/>
            <pc:sldMk cId="1781468713" sldId="3688"/>
            <ac:spMk id="79" creationId="{EA8B8D08-7B80-7470-6328-F8123DD8DBD6}"/>
          </ac:spMkLst>
        </pc:spChg>
        <pc:spChg chg="add mod">
          <ac:chgData name="友美 山﨑" userId="7b25e37ca7f83a67" providerId="LiveId" clId="{D968202A-90FD-4BA8-BBE0-BACF6D498E67}" dt="2025-01-13T05:44:06.252" v="1739"/>
          <ac:spMkLst>
            <pc:docMk/>
            <pc:sldMk cId="1781468713" sldId="3688"/>
            <ac:spMk id="80" creationId="{61C1EB1A-FC16-C60A-4B49-F76E4FA7B390}"/>
          </ac:spMkLst>
        </pc:spChg>
        <pc:spChg chg="add mod">
          <ac:chgData name="友美 山﨑" userId="7b25e37ca7f83a67" providerId="LiveId" clId="{D968202A-90FD-4BA8-BBE0-BACF6D498E67}" dt="2025-01-13T05:44:22.917" v="1827" actId="1036"/>
          <ac:spMkLst>
            <pc:docMk/>
            <pc:sldMk cId="1781468713" sldId="3688"/>
            <ac:spMk id="81" creationId="{492BFD79-2ECC-E2D0-88CE-F4FA4DD3CF02}"/>
          </ac:spMkLst>
        </pc:spChg>
        <pc:spChg chg="add mod">
          <ac:chgData name="友美 山﨑" userId="7b25e37ca7f83a67" providerId="LiveId" clId="{D968202A-90FD-4BA8-BBE0-BACF6D498E67}" dt="2025-01-13T05:45:23.338" v="1912" actId="1037"/>
          <ac:spMkLst>
            <pc:docMk/>
            <pc:sldMk cId="1781468713" sldId="3688"/>
            <ac:spMk id="82" creationId="{86E8E6EE-9C65-555C-A072-566CF0718AB8}"/>
          </ac:spMkLst>
        </pc:spChg>
        <pc:spChg chg="add mod">
          <ac:chgData name="友美 山﨑" userId="7b25e37ca7f83a67" providerId="LiveId" clId="{D968202A-90FD-4BA8-BBE0-BACF6D498E67}" dt="2025-01-13T05:45:41.551" v="1992" actId="1036"/>
          <ac:spMkLst>
            <pc:docMk/>
            <pc:sldMk cId="1781468713" sldId="3688"/>
            <ac:spMk id="83" creationId="{E376A27A-56CE-ACB6-1C86-5D24F783918D}"/>
          </ac:spMkLst>
        </pc:spChg>
        <pc:spChg chg="add mod">
          <ac:chgData name="友美 山﨑" userId="7b25e37ca7f83a67" providerId="LiveId" clId="{D968202A-90FD-4BA8-BBE0-BACF6D498E67}" dt="2025-01-13T05:49:27.271" v="2667" actId="1037"/>
          <ac:spMkLst>
            <pc:docMk/>
            <pc:sldMk cId="1781468713" sldId="3688"/>
            <ac:spMk id="84" creationId="{A4E15701-47F2-AACB-45B0-CE6FEAF1C2EF}"/>
          </ac:spMkLst>
        </pc:spChg>
        <pc:spChg chg="add mod">
          <ac:chgData name="友美 山﨑" userId="7b25e37ca7f83a67" providerId="LiveId" clId="{D968202A-90FD-4BA8-BBE0-BACF6D498E67}" dt="2025-01-13T05:47:01.300" v="2267" actId="1038"/>
          <ac:spMkLst>
            <pc:docMk/>
            <pc:sldMk cId="1781468713" sldId="3688"/>
            <ac:spMk id="85" creationId="{E9B426DB-B5F8-83F2-009A-EECCF7F4D26A}"/>
          </ac:spMkLst>
        </pc:spChg>
        <pc:grpChg chg="mod">
          <ac:chgData name="友美 山﨑" userId="7b25e37ca7f83a67" providerId="LiveId" clId="{D968202A-90FD-4BA8-BBE0-BACF6D498E67}" dt="2025-01-13T05:48:48.875" v="2555" actId="1035"/>
          <ac:grpSpMkLst>
            <pc:docMk/>
            <pc:sldMk cId="1781468713" sldId="3688"/>
            <ac:grpSpMk id="5" creationId="{D3DCB935-17A7-CD09-23F0-064F6A094160}"/>
          </ac:grpSpMkLst>
        </pc:grpChg>
        <pc:picChg chg="del mod">
          <ac:chgData name="友美 山﨑" userId="7b25e37ca7f83a67" providerId="LiveId" clId="{D968202A-90FD-4BA8-BBE0-BACF6D498E67}" dt="2025-01-13T05:48:00.173" v="2469" actId="478"/>
          <ac:picMkLst>
            <pc:docMk/>
            <pc:sldMk cId="1781468713" sldId="3688"/>
            <ac:picMk id="45" creationId="{5A5E8F25-E3A1-B428-243A-C30157A8EF1E}"/>
          </ac:picMkLst>
        </pc:picChg>
        <pc:picChg chg="add del">
          <ac:chgData name="友美 山﨑" userId="7b25e37ca7f83a67" providerId="LiveId" clId="{D968202A-90FD-4BA8-BBE0-BACF6D498E67}" dt="2025-01-13T05:33:06.027" v="135" actId="478"/>
          <ac:picMkLst>
            <pc:docMk/>
            <pc:sldMk cId="1781468713" sldId="3688"/>
            <ac:picMk id="49" creationId="{666E02F8-548D-5097-700B-CCAC8289EE27}"/>
          </ac:picMkLst>
        </pc:picChg>
        <pc:picChg chg="add mod modCrop">
          <ac:chgData name="友美 山﨑" userId="7b25e37ca7f83a67" providerId="LiveId" clId="{D968202A-90FD-4BA8-BBE0-BACF6D498E67}" dt="2025-01-13T05:42:17.227" v="1504" actId="1038"/>
          <ac:picMkLst>
            <pc:docMk/>
            <pc:sldMk cId="1781468713" sldId="3688"/>
            <ac:picMk id="65" creationId="{76F812F4-2AAF-CFDA-471F-E6C0D4F87C07}"/>
          </ac:picMkLst>
        </pc:picChg>
        <pc:picChg chg="add del mod">
          <ac:chgData name="友美 山﨑" userId="7b25e37ca7f83a67" providerId="LiveId" clId="{D968202A-90FD-4BA8-BBE0-BACF6D498E67}" dt="2025-01-13T05:48:52.793" v="2557" actId="478"/>
          <ac:picMkLst>
            <pc:docMk/>
            <pc:sldMk cId="1781468713" sldId="3688"/>
            <ac:picMk id="89" creationId="{6B155C55-F4AA-3215-A70A-E0E08783C13E}"/>
          </ac:picMkLst>
        </pc:picChg>
        <pc:cxnChg chg="mod">
          <ac:chgData name="友美 山﨑" userId="7b25e37ca7f83a67" providerId="LiveId" clId="{D968202A-90FD-4BA8-BBE0-BACF6D498E67}" dt="2025-01-13T05:35:57.610" v="572" actId="208"/>
          <ac:cxnSpMkLst>
            <pc:docMk/>
            <pc:sldMk cId="1781468713" sldId="3688"/>
            <ac:cxnSpMk id="42" creationId="{B494D68C-9DE2-E46A-6759-942FA919A816}"/>
          </ac:cxnSpMkLst>
        </pc:cxnChg>
        <pc:cxnChg chg="mod">
          <ac:chgData name="友美 山﨑" userId="7b25e37ca7f83a67" providerId="LiveId" clId="{D968202A-90FD-4BA8-BBE0-BACF6D498E67}" dt="2025-01-13T05:35:33.117" v="569" actId="208"/>
          <ac:cxnSpMkLst>
            <pc:docMk/>
            <pc:sldMk cId="1781468713" sldId="3688"/>
            <ac:cxnSpMk id="43" creationId="{F3F0F4E5-67D5-E9B5-9418-00CBA9261B07}"/>
          </ac:cxnSpMkLst>
        </pc:cxnChg>
        <pc:cxnChg chg="mod">
          <ac:chgData name="友美 山﨑" userId="7b25e37ca7f83a67" providerId="LiveId" clId="{D968202A-90FD-4BA8-BBE0-BACF6D498E67}" dt="2025-01-13T05:30:01.426" v="133" actId="208"/>
          <ac:cxnSpMkLst>
            <pc:docMk/>
            <pc:sldMk cId="1781468713" sldId="3688"/>
            <ac:cxnSpMk id="47" creationId="{84B96767-D1EA-3C0B-A826-7D820D306753}"/>
          </ac:cxnSpMkLst>
        </pc:cxnChg>
        <pc:cxnChg chg="del">
          <ac:chgData name="友美 山﨑" userId="7b25e37ca7f83a67" providerId="LiveId" clId="{D968202A-90FD-4BA8-BBE0-BACF6D498E67}" dt="2025-01-13T05:29:47.467" v="130" actId="478"/>
          <ac:cxnSpMkLst>
            <pc:docMk/>
            <pc:sldMk cId="1781468713" sldId="3688"/>
            <ac:cxnSpMk id="55" creationId="{7B1E3A9D-3450-C862-36E4-E7FF1976DF2D}"/>
          </ac:cxnSpMkLst>
        </pc:cxnChg>
        <pc:cxnChg chg="del mod">
          <ac:chgData name="友美 山﨑" userId="7b25e37ca7f83a67" providerId="LiveId" clId="{D968202A-90FD-4BA8-BBE0-BACF6D498E67}" dt="2025-01-13T05:48:06.154" v="2471" actId="478"/>
          <ac:cxnSpMkLst>
            <pc:docMk/>
            <pc:sldMk cId="1781468713" sldId="3688"/>
            <ac:cxnSpMk id="56" creationId="{8D7DB51C-666C-45F7-2069-8D40964BB164}"/>
          </ac:cxnSpMkLst>
        </pc:cxnChg>
        <pc:cxnChg chg="del mod">
          <ac:chgData name="友美 山﨑" userId="7b25e37ca7f83a67" providerId="LiveId" clId="{D968202A-90FD-4BA8-BBE0-BACF6D498E67}" dt="2025-01-13T05:48:06.154" v="2471" actId="478"/>
          <ac:cxnSpMkLst>
            <pc:docMk/>
            <pc:sldMk cId="1781468713" sldId="3688"/>
            <ac:cxnSpMk id="57" creationId="{03B2A070-D8BF-D082-5AF8-B1D1C6BD56DD}"/>
          </ac:cxnSpMkLst>
        </pc:cxnChg>
        <pc:cxnChg chg="del mod">
          <ac:chgData name="友美 山﨑" userId="7b25e37ca7f83a67" providerId="LiveId" clId="{D968202A-90FD-4BA8-BBE0-BACF6D498E67}" dt="2025-01-13T05:48:03.570" v="2470" actId="478"/>
          <ac:cxnSpMkLst>
            <pc:docMk/>
            <pc:sldMk cId="1781468713" sldId="3688"/>
            <ac:cxnSpMk id="58" creationId="{FBB5F9A1-0E58-EC58-7FBF-350BB0BE0A3F}"/>
          </ac:cxnSpMkLst>
        </pc:cxnChg>
        <pc:cxnChg chg="del mod">
          <ac:chgData name="友美 山﨑" userId="7b25e37ca7f83a67" providerId="LiveId" clId="{D968202A-90FD-4BA8-BBE0-BACF6D498E67}" dt="2025-01-13T05:48:06.154" v="2471" actId="478"/>
          <ac:cxnSpMkLst>
            <pc:docMk/>
            <pc:sldMk cId="1781468713" sldId="3688"/>
            <ac:cxnSpMk id="59" creationId="{8DDE9BB6-9900-6245-2D8B-21AF4617B49F}"/>
          </ac:cxnSpMkLst>
        </pc:cxnChg>
        <pc:cxnChg chg="add mod">
          <ac:chgData name="友美 山﨑" userId="7b25e37ca7f83a67" providerId="LiveId" clId="{D968202A-90FD-4BA8-BBE0-BACF6D498E67}" dt="2025-01-13T05:47:23.583" v="2377" actId="1035"/>
          <ac:cxnSpMkLst>
            <pc:docMk/>
            <pc:sldMk cId="1781468713" sldId="3688"/>
            <ac:cxnSpMk id="86" creationId="{2C489254-B127-4B9A-7CDE-61447CE999CF}"/>
          </ac:cxnSpMkLst>
        </pc:cxnChg>
        <pc:cxnChg chg="add mod">
          <ac:chgData name="友美 山﨑" userId="7b25e37ca7f83a67" providerId="LiveId" clId="{D968202A-90FD-4BA8-BBE0-BACF6D498E67}" dt="2025-01-13T05:47:50.443" v="2468" actId="1036"/>
          <ac:cxnSpMkLst>
            <pc:docMk/>
            <pc:sldMk cId="1781468713" sldId="3688"/>
            <ac:cxnSpMk id="87" creationId="{9CD491CB-AF5E-F41F-8ACA-9DFD95B2C384}"/>
          </ac:cxnSpMkLst>
        </pc:cxnChg>
        <pc:cxnChg chg="add mod">
          <ac:chgData name="友美 山﨑" userId="7b25e37ca7f83a67" providerId="LiveId" clId="{D968202A-90FD-4BA8-BBE0-BACF6D498E67}" dt="2025-01-13T05:49:22.377" v="2662" actId="1038"/>
          <ac:cxnSpMkLst>
            <pc:docMk/>
            <pc:sldMk cId="1781468713" sldId="3688"/>
            <ac:cxnSpMk id="88" creationId="{933FF39A-7F56-499B-FCFC-F61CA0F34F44}"/>
          </ac:cxnSpMkLst>
        </pc:cxnChg>
        <pc:cxnChg chg="add mod">
          <ac:chgData name="友美 山﨑" userId="7b25e37ca7f83a67" providerId="LiveId" clId="{D968202A-90FD-4BA8-BBE0-BACF6D498E67}" dt="2025-01-13T05:48:48.875" v="2555" actId="1035"/>
          <ac:cxnSpMkLst>
            <pc:docMk/>
            <pc:sldMk cId="1781468713" sldId="3688"/>
            <ac:cxnSpMk id="90" creationId="{02547A39-F596-E0B7-823D-1E08E10615C1}"/>
          </ac:cxnSpMkLst>
        </pc:cxnChg>
        <pc:cxnChg chg="add mod">
          <ac:chgData name="友美 山﨑" userId="7b25e37ca7f83a67" providerId="LiveId" clId="{D968202A-90FD-4BA8-BBE0-BACF6D498E67}" dt="2025-01-13T05:49:18.079" v="2649" actId="1038"/>
          <ac:cxnSpMkLst>
            <pc:docMk/>
            <pc:sldMk cId="1781468713" sldId="3688"/>
            <ac:cxnSpMk id="91" creationId="{6619DF06-ADD0-6DF0-45EA-9230FBC306AA}"/>
          </ac:cxnSpMkLst>
        </pc:cxnChg>
      </pc:sldChg>
      <pc:sldChg chg="modSp mod">
        <pc:chgData name="友美 山﨑" userId="7b25e37ca7f83a67" providerId="LiveId" clId="{D968202A-90FD-4BA8-BBE0-BACF6D498E67}" dt="2025-01-13T06:58:49.165" v="2724" actId="20577"/>
        <pc:sldMkLst>
          <pc:docMk/>
          <pc:sldMk cId="1836875351" sldId="3784"/>
        </pc:sldMkLst>
        <pc:spChg chg="mod">
          <ac:chgData name="友美 山﨑" userId="7b25e37ca7f83a67" providerId="LiveId" clId="{D968202A-90FD-4BA8-BBE0-BACF6D498E67}" dt="2025-01-13T06:58:49.165" v="2724" actId="20577"/>
          <ac:spMkLst>
            <pc:docMk/>
            <pc:sldMk cId="1836875351" sldId="3784"/>
            <ac:spMk id="2" creationId="{EF06968E-6DAF-33A4-F380-AAE22C110957}"/>
          </ac:spMkLst>
        </pc:spChg>
      </pc:sldChg>
      <pc:sldChg chg="modSp mod">
        <pc:chgData name="友美 山﨑" userId="7b25e37ca7f83a67" providerId="LiveId" clId="{D968202A-90FD-4BA8-BBE0-BACF6D498E67}" dt="2025-01-13T07:00:43.556" v="2753" actId="20577"/>
        <pc:sldMkLst>
          <pc:docMk/>
          <pc:sldMk cId="2280236884" sldId="3786"/>
        </pc:sldMkLst>
        <pc:graphicFrameChg chg="mod modGraphic">
          <ac:chgData name="友美 山﨑" userId="7b25e37ca7f83a67" providerId="LiveId" clId="{D968202A-90FD-4BA8-BBE0-BACF6D498E67}" dt="2025-01-13T07:00:43.556" v="2753" actId="20577"/>
          <ac:graphicFrameMkLst>
            <pc:docMk/>
            <pc:sldMk cId="2280236884" sldId="3786"/>
            <ac:graphicFrameMk id="4" creationId="{1BFE8A36-B049-21A4-8186-7F404063FE20}"/>
          </ac:graphicFrameMkLst>
        </pc:graphicFrame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2CD582-C255-41E7-8331-7D9D8CC39059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0BF428-79D7-45EC-AF5C-C30FC110DD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83005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B666B3-290E-4EF7-88A0-BC53C1912469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40DBD0-E500-4A0F-AF2C-49B70B477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66215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0DBD0-E500-4A0F-AF2C-49B70B477CB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70791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28C0AA-5A02-4A81-B8A6-75DB114E2E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B237D28-1E19-4F2A-957B-3BA8709152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5CC2CF9-243A-4127-8639-C232356F0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1516-1D6A-47AD-9DC8-3B35E963C4B8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CCADFCC-74E2-4F15-AEF9-F9F24533C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47BDB0-5402-4347-A551-6AA2B471A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B1382-7354-4129-8F33-32DECF22F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352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3D4844-ECA9-4D2C-A712-0AA8C5395A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B7ABA31-0287-4B05-8DA1-27A8770DEA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6C52B67-1602-4CA7-B5EA-5D8056941A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1516-1D6A-47AD-9DC8-3B35E963C4B8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12368AC-3649-45C9-A09F-C7A32FF13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0FDB2F-FE8E-42C3-8618-D25697539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B1382-7354-4129-8F33-32DECF22F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563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2513D5D-1D19-4462-B800-B32D4ACCC8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4E962A5-5D09-4F1F-9960-22C6AE4E3B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6C1EA7-B05A-4264-B04E-7B51A877F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1516-1D6A-47AD-9DC8-3B35E963C4B8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CC7E441-4FEE-4F73-898D-4F9FFC32DB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98F955-3A42-4CC8-8E18-A7539A530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B1382-7354-4129-8F33-32DECF22F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4012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05EE20-ADF1-4A10-932A-60E20AA26A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3143DB6-1F68-405F-9B51-C4FD326B2E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604AA2-44BD-4526-9312-3EE3D32F53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1516-1D6A-47AD-9DC8-3B35E963C4B8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052CFD8-7831-4CAC-BCC7-7661713B6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CCC8D0E-2326-4540-B3AC-6639EC0A7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B1382-7354-4129-8F33-32DECF22F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062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FFD324-4003-4F9A-A5DB-9B8FEE4A30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43CCB83-B7EA-40D2-B588-CC34EFD56C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71C2688-9AE2-46FF-84D8-3D8765BABF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1516-1D6A-47AD-9DC8-3B35E963C4B8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6B6EFAD-0501-4075-89DB-732ECDBD4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B2CD33B-7FAB-4EE5-9396-DFD14A6A1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B1382-7354-4129-8F33-32DECF22F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417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B78047-2D7A-4DAE-806A-C8CAB7B88D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9AD4D96-E7D5-45C9-A25C-3D331FB82F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E91D30C-37FF-4CAC-BCBE-894888838C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A3F9751-142A-4A73-90D3-90014F8E72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1516-1D6A-47AD-9DC8-3B35E963C4B8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F09FDD2-2DC2-4C3E-B0EE-5AC6B13B33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FCF6E04-0A4C-4B33-B54E-3413B71FC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B1382-7354-4129-8F33-32DECF22F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3964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6F2913-DBEC-427B-ADF1-B338073008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4EC80DF-2565-4AC5-9B84-5EE8721610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DD3DD4B-75FB-4E56-BE70-C367535B0D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CAA28F1-4D37-4AF8-83BA-5585DE03E1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28641FB-C1C5-4265-A6F0-429834DC30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31ACE89-E8F5-4220-A92B-F633E785C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1516-1D6A-47AD-9DC8-3B35E963C4B8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3755B31-E072-4FB4-915C-1C9463DCD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1A66F80-C0E8-4D9F-8F95-85FF275B30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B1382-7354-4129-8F33-32DECF22F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986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29C67D-DC17-4A7E-B792-B39B34FA0A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1941D3B-61F1-4212-8B06-F51C09359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1516-1D6A-47AD-9DC8-3B35E963C4B8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CF113DE-DF14-4285-8EAD-17A30B9C9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4D68B3B-D1C0-4DB8-8569-34BEDADD0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B1382-7354-4129-8F33-32DECF22F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0879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637C05A-D538-4AB3-9E4A-1F21D846B0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1516-1D6A-47AD-9DC8-3B35E963C4B8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3C3B3C8-CD63-46DE-8C06-61A11FECA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D3A6E0A-EAAA-45AB-85E2-809A4AAD4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B1382-7354-4129-8F33-32DECF22F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0515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91D589-0789-4539-96B2-47223857D7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4A9DBB7-B007-4BB0-A822-49EEC38132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E82EA7A-4F53-41E4-94FE-3821DF026E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03F6C66-962D-4F20-BD7A-161ED2104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1516-1D6A-47AD-9DC8-3B35E963C4B8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736F428-868C-43F4-BD05-9017FB4B9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48FC1EA-CD44-44E6-963A-F5E411EEF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B1382-7354-4129-8F33-32DECF22F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3432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0DC3E23-2C8E-4576-9588-703D7534E2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5BEE2FA-77E4-4F1F-A5A7-650F90736C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A033C30-51AA-4C33-B30A-BADA3FC0C5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2CB0541-43A9-42A0-A8D7-CB0D52DBA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71516-1D6A-47AD-9DC8-3B35E963C4B8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909D437-3B0D-40D5-AD82-995B4B7C5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55BC321-20E3-4371-BD5A-8E9200A2C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B1382-7354-4129-8F33-32DECF22F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7983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43F0756-D995-453D-BAE6-EF8ACEEE55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EE7183E-539A-4880-83CF-822F2DD808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830F275-3023-487B-A616-655EACCF15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071516-1D6A-47AD-9DC8-3B35E963C4B8}" type="datetimeFigureOut">
              <a:rPr kumimoji="1" lang="ja-JP" altLang="en-US" smtClean="0"/>
              <a:t>2025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0519BF2-9A46-4812-B012-EB1F07AD66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C70B74-1BE8-4837-A613-6B76BE8454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3B1382-7354-4129-8F33-32DECF22FA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9676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1D58DDE-BEC1-4A29-957E-C060AB71F256}"/>
              </a:ext>
            </a:extLst>
          </p:cNvPr>
          <p:cNvSpPr txBox="1"/>
          <p:nvPr/>
        </p:nvSpPr>
        <p:spPr>
          <a:xfrm>
            <a:off x="3480844" y="1298585"/>
            <a:ext cx="2579933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356 </a:t>
            </a:r>
            <a:r>
              <a:rPr kumimoji="1"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women</a:t>
            </a:r>
            <a:r>
              <a:rPr kumimoji="1"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were</a:t>
            </a:r>
            <a:r>
              <a:rPr kumimoji="1"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nrolled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04A2CCC-5F0C-438D-9E9C-BFB2BE0DD33C}"/>
              </a:ext>
            </a:extLst>
          </p:cNvPr>
          <p:cNvSpPr txBox="1"/>
          <p:nvPr/>
        </p:nvSpPr>
        <p:spPr>
          <a:xfrm>
            <a:off x="6999570" y="1438622"/>
            <a:ext cx="4810499" cy="107721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53</a:t>
            </a:r>
            <a:r>
              <a:rPr kumimoji="1"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women</a:t>
            </a:r>
            <a:r>
              <a:rPr kumimoji="1"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were</a:t>
            </a:r>
            <a:r>
              <a:rPr kumimoji="1"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excluded</a:t>
            </a:r>
            <a:endParaRPr lang="en-US" altLang="ja-JP" sz="1600" u="sng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  <a:p>
            <a:r>
              <a:rPr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  </a:t>
            </a:r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24</a:t>
            </a:r>
            <a:r>
              <a:rPr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 </a:t>
            </a:r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transfer with diagnosed PE from another unit</a:t>
            </a:r>
            <a:r>
              <a:rPr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　</a:t>
            </a:r>
            <a:endParaRPr lang="en-US" altLang="ja-JP" sz="16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  <a:p>
            <a:r>
              <a:rPr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  </a:t>
            </a:r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6 diagnosed PE at visit1</a:t>
            </a:r>
          </a:p>
          <a:p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  13</a:t>
            </a:r>
            <a:r>
              <a:rPr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 </a:t>
            </a:r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had multiple-gestation pregnancy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E2C131F-8469-4CD1-9988-EE3F19CB0AD4}"/>
              </a:ext>
            </a:extLst>
          </p:cNvPr>
          <p:cNvSpPr txBox="1"/>
          <p:nvPr/>
        </p:nvSpPr>
        <p:spPr>
          <a:xfrm>
            <a:off x="2702568" y="4535897"/>
            <a:ext cx="2280243" cy="58477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242</a:t>
            </a:r>
            <a:r>
              <a:rPr kumimoji="1"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did not have </a:t>
            </a:r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PE</a:t>
            </a:r>
            <a:endParaRPr kumimoji="1" lang="en-US" altLang="ja-JP" sz="16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  <a:p>
            <a:pPr algn="ctr"/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(79.9%)</a:t>
            </a:r>
            <a:endParaRPr kumimoji="1" lang="ja-JP" altLang="en-US" sz="16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19D056A-BD2C-4043-AFC4-FA23A51A6E9E}"/>
              </a:ext>
            </a:extLst>
          </p:cNvPr>
          <p:cNvSpPr txBox="1"/>
          <p:nvPr/>
        </p:nvSpPr>
        <p:spPr>
          <a:xfrm>
            <a:off x="5818752" y="4547633"/>
            <a:ext cx="2386760" cy="58477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61</a:t>
            </a:r>
            <a:r>
              <a:rPr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developed PE</a:t>
            </a:r>
          </a:p>
          <a:p>
            <a:pPr algn="ctr"/>
            <a:r>
              <a:rPr kumimoji="1"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(</a:t>
            </a:r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20.1%)</a:t>
            </a:r>
            <a:endParaRPr kumimoji="1" lang="ja-JP" altLang="en-US" sz="16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063E1C8C-EDAD-489E-8CA9-2EB43AB4B4CB}"/>
              </a:ext>
            </a:extLst>
          </p:cNvPr>
          <p:cNvSpPr txBox="1"/>
          <p:nvPr/>
        </p:nvSpPr>
        <p:spPr>
          <a:xfrm>
            <a:off x="4344191" y="5780045"/>
            <a:ext cx="2299259" cy="58477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21 developed PE</a:t>
            </a:r>
          </a:p>
          <a:p>
            <a:pPr algn="ctr"/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within 1</a:t>
            </a:r>
            <a:r>
              <a:rPr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week (6.9%)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9D5EEFD-32B7-409C-B200-D98CACE7B8C9}"/>
              </a:ext>
            </a:extLst>
          </p:cNvPr>
          <p:cNvSpPr txBox="1"/>
          <p:nvPr/>
        </p:nvSpPr>
        <p:spPr>
          <a:xfrm>
            <a:off x="7559480" y="5790477"/>
            <a:ext cx="2409503" cy="58477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40 developed PE</a:t>
            </a:r>
          </a:p>
          <a:p>
            <a:pPr algn="ctr"/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within 4 weeks (13.2%)</a:t>
            </a:r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7BCE77FA-C0DD-4962-AD7C-4C420383E935}"/>
              </a:ext>
            </a:extLst>
          </p:cNvPr>
          <p:cNvCxnSpPr>
            <a:cxnSpLocks/>
          </p:cNvCxnSpPr>
          <p:nvPr/>
        </p:nvCxnSpPr>
        <p:spPr>
          <a:xfrm>
            <a:off x="4755800" y="1659851"/>
            <a:ext cx="0" cy="115933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3F260197-84D2-41B8-9E7C-F039E9BE8973}"/>
              </a:ext>
            </a:extLst>
          </p:cNvPr>
          <p:cNvCxnSpPr>
            <a:cxnSpLocks/>
          </p:cNvCxnSpPr>
          <p:nvPr/>
        </p:nvCxnSpPr>
        <p:spPr>
          <a:xfrm>
            <a:off x="4755800" y="2129997"/>
            <a:ext cx="22546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79469906-623B-4C1D-884D-DF1D5B119F8A}"/>
              </a:ext>
            </a:extLst>
          </p:cNvPr>
          <p:cNvCxnSpPr>
            <a:cxnSpLocks/>
          </p:cNvCxnSpPr>
          <p:nvPr/>
        </p:nvCxnSpPr>
        <p:spPr>
          <a:xfrm flipH="1">
            <a:off x="4755800" y="3941710"/>
            <a:ext cx="5033" cy="29904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204140A3-8FE4-4284-A033-A70A7750407E}"/>
              </a:ext>
            </a:extLst>
          </p:cNvPr>
          <p:cNvCxnSpPr>
            <a:cxnSpLocks/>
          </p:cNvCxnSpPr>
          <p:nvPr/>
        </p:nvCxnSpPr>
        <p:spPr>
          <a:xfrm>
            <a:off x="3841723" y="4240758"/>
            <a:ext cx="315317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0E920E74-8982-4DE1-9A74-BF5628709834}"/>
              </a:ext>
            </a:extLst>
          </p:cNvPr>
          <p:cNvCxnSpPr>
            <a:cxnSpLocks/>
          </p:cNvCxnSpPr>
          <p:nvPr/>
        </p:nvCxnSpPr>
        <p:spPr>
          <a:xfrm>
            <a:off x="3841723" y="4240758"/>
            <a:ext cx="0" cy="28388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2CAC9D9A-76C1-4637-AD67-06B627D6E10E}"/>
              </a:ext>
            </a:extLst>
          </p:cNvPr>
          <p:cNvCxnSpPr>
            <a:cxnSpLocks/>
          </p:cNvCxnSpPr>
          <p:nvPr/>
        </p:nvCxnSpPr>
        <p:spPr>
          <a:xfrm flipH="1">
            <a:off x="6994901" y="4240758"/>
            <a:ext cx="5032" cy="29904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42B22F99-2DA4-4C13-94ED-6F8D0407ECA4}"/>
              </a:ext>
            </a:extLst>
          </p:cNvPr>
          <p:cNvCxnSpPr>
            <a:cxnSpLocks/>
          </p:cNvCxnSpPr>
          <p:nvPr/>
        </p:nvCxnSpPr>
        <p:spPr>
          <a:xfrm>
            <a:off x="6996881" y="5158662"/>
            <a:ext cx="0" cy="25880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89748CA8-333F-4354-8BE2-6DA4987177DA}"/>
              </a:ext>
            </a:extLst>
          </p:cNvPr>
          <p:cNvCxnSpPr>
            <a:cxnSpLocks/>
          </p:cNvCxnSpPr>
          <p:nvPr/>
        </p:nvCxnSpPr>
        <p:spPr>
          <a:xfrm>
            <a:off x="5592963" y="5438301"/>
            <a:ext cx="302566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矢印コネクタ 47">
            <a:extLst>
              <a:ext uri="{FF2B5EF4-FFF2-40B4-BE49-F238E27FC236}">
                <a16:creationId xmlns:a16="http://schemas.microsoft.com/office/drawing/2014/main" id="{980A6471-76D1-406F-8B56-0CDB4686F58F}"/>
              </a:ext>
            </a:extLst>
          </p:cNvPr>
          <p:cNvCxnSpPr>
            <a:cxnSpLocks/>
          </p:cNvCxnSpPr>
          <p:nvPr/>
        </p:nvCxnSpPr>
        <p:spPr>
          <a:xfrm>
            <a:off x="5592962" y="5444436"/>
            <a:ext cx="0" cy="32184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C6E757A0-B83F-4076-ABFC-7F55365B3734}"/>
              </a:ext>
            </a:extLst>
          </p:cNvPr>
          <p:cNvSpPr txBox="1"/>
          <p:nvPr/>
        </p:nvSpPr>
        <p:spPr>
          <a:xfrm>
            <a:off x="3447163" y="2844318"/>
            <a:ext cx="3612856" cy="107721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303</a:t>
            </a:r>
            <a:r>
              <a:rPr kumimoji="1"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women</a:t>
            </a:r>
            <a:r>
              <a:rPr kumimoji="1"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were</a:t>
            </a:r>
            <a:r>
              <a:rPr kumimoji="1"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included in analysis</a:t>
            </a:r>
          </a:p>
          <a:p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  54 at</a:t>
            </a:r>
            <a:r>
              <a:rPr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primary facilities</a:t>
            </a:r>
          </a:p>
          <a:p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  </a:t>
            </a:r>
            <a:r>
              <a:rPr kumimoji="1"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08</a:t>
            </a:r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at secondary facilities</a:t>
            </a:r>
            <a:endParaRPr kumimoji="1" lang="en-US" altLang="ja-JP" sz="16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  <a:p>
            <a:r>
              <a:rPr lang="ja-JP" altLang="en-US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  </a:t>
            </a:r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41</a:t>
            </a:r>
            <a:r>
              <a:rPr lang="en-US" altLang="ja-JP" sz="1600" dirty="0">
                <a:solidFill>
                  <a:srgbClr val="FF0000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t a </a:t>
            </a:r>
            <a:r>
              <a:rPr lang="en-US" altLang="ja-JP" sz="1600" kern="100" dirty="0">
                <a:effectLst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tertiary center</a:t>
            </a:r>
            <a:endParaRPr lang="en-US" altLang="ja-JP" sz="16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2" name="直線矢印コネクタ 1">
            <a:extLst>
              <a:ext uri="{FF2B5EF4-FFF2-40B4-BE49-F238E27FC236}">
                <a16:creationId xmlns:a16="http://schemas.microsoft.com/office/drawing/2014/main" id="{ACB8F226-DF84-EE25-8377-3F946AF8E147}"/>
              </a:ext>
            </a:extLst>
          </p:cNvPr>
          <p:cNvCxnSpPr>
            <a:cxnSpLocks/>
          </p:cNvCxnSpPr>
          <p:nvPr/>
        </p:nvCxnSpPr>
        <p:spPr>
          <a:xfrm>
            <a:off x="8611574" y="5451226"/>
            <a:ext cx="0" cy="32184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7BB86CC-C147-D7F6-9C2E-ACF2F3A488F5}"/>
              </a:ext>
            </a:extLst>
          </p:cNvPr>
          <p:cNvSpPr txBox="1"/>
          <p:nvPr/>
        </p:nvSpPr>
        <p:spPr>
          <a:xfrm>
            <a:off x="520991" y="329598"/>
            <a:ext cx="108109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: Number of women enrolled and outcomes of PE development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3903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32</TotalTime>
  <Words>95</Words>
  <Application>Microsoft Office PowerPoint</Application>
  <PresentationFormat>ワイド画面</PresentationFormat>
  <Paragraphs>1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2020･11･28</dc:title>
  <dc:creator>広島大学産婦人科</dc:creator>
  <cp:lastModifiedBy>友美 山﨑</cp:lastModifiedBy>
  <cp:revision>507</cp:revision>
  <cp:lastPrinted>2025-01-08T02:35:06Z</cp:lastPrinted>
  <dcterms:created xsi:type="dcterms:W3CDTF">2020-11-28T01:18:27Z</dcterms:created>
  <dcterms:modified xsi:type="dcterms:W3CDTF">2025-06-10T06:24:27Z</dcterms:modified>
</cp:coreProperties>
</file>